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40" d="100"/>
          <a:sy n="140" d="100"/>
        </p:scale>
        <p:origin x="-85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737" y="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/>
          <a:lstStyle>
            <a:lvl1pPr algn="r">
              <a:defRPr sz="1200"/>
            </a:lvl1pPr>
          </a:lstStyle>
          <a:p>
            <a:fld id="{0C94D679-86A5-444D-8352-038A242B7AA5}" type="datetimeFigureOut">
              <a:rPr lang="en-CA" smtClean="0"/>
              <a:t>2017-02-0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7300" y="720725"/>
            <a:ext cx="48006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04" tIns="47352" rIns="94704" bIns="47352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0859" y="4559916"/>
            <a:ext cx="5853483" cy="4320867"/>
          </a:xfrm>
          <a:prstGeom prst="rect">
            <a:avLst/>
          </a:prstGeom>
        </p:spPr>
        <p:txBody>
          <a:bodyPr vert="horz" lIns="94704" tIns="47352" rIns="94704" bIns="4735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83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737" y="911983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 anchor="b"/>
          <a:lstStyle>
            <a:lvl1pPr algn="r">
              <a:defRPr sz="1200"/>
            </a:lvl1pPr>
          </a:lstStyle>
          <a:p>
            <a:fld id="{ACD6559C-E1B9-4EBC-8516-7C7724E77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0572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D2561-4133-4350-BC8C-ABFE60F8C53F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413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ACCCF-E931-42B6-81EC-DF79F700D95A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965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6383C-328D-4048-AE9E-2E46D75D8C77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687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3B0E6-D34C-4A69-9A78-4926FBA0B0A1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803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5A97-DF27-40C2-9432-5BE375F21439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04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9CB97-8EB4-4980-99E9-FDDB8E219648}" type="datetime1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696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07DD-E821-4F7B-9001-D86B06916914}" type="datetime1">
              <a:rPr lang="en-US" smtClean="0"/>
              <a:t>2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489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4F5E-DF64-48F9-95F9-156FF0A4C0A7}" type="datetime1">
              <a:rPr lang="en-US" smtClean="0"/>
              <a:t>2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910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7164-949A-4FA1-B387-0F1227248824}" type="datetime1">
              <a:rPr lang="en-US" smtClean="0"/>
              <a:t>2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817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87F7-5499-4339-B0AE-4CF173FF1E86}" type="datetime1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16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25917-9968-4E14-A5CC-E3F082F69F88}" type="datetime1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499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22B648-2815-4CC7-B17D-A00AFB5B0973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343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6065979"/>
              </p:ext>
            </p:extLst>
          </p:nvPr>
        </p:nvGraphicFramePr>
        <p:xfrm>
          <a:off x="526212" y="1903980"/>
          <a:ext cx="8229599" cy="2244876"/>
        </p:xfrm>
        <a:graphic>
          <a:graphicData uri="http://schemas.openxmlformats.org/drawingml/2006/table">
            <a:tbl>
              <a:tblPr/>
              <a:tblGrid>
                <a:gridCol w="806560"/>
                <a:gridCol w="984003"/>
                <a:gridCol w="822691"/>
                <a:gridCol w="946363"/>
                <a:gridCol w="935610"/>
                <a:gridCol w="1086167"/>
                <a:gridCol w="992069"/>
                <a:gridCol w="774297"/>
                <a:gridCol w="881839"/>
              </a:tblGrid>
              <a:tr h="317473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CA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1 Table</a:t>
                      </a:r>
                      <a:r>
                        <a:rPr lang="en-CA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. 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umber of protein-coding sequences related to stress response survival capacity of the five subspecies of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lavibacter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ichiganensis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766"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654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bspecies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xidative stress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smotic stress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ld and heat shock 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ma factors 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lenite detoxification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ibiotics and toxic coumpound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thers</a:t>
                      </a:r>
                      <a:r>
                        <a:rPr lang="en-CA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Total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212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m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7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2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9212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s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7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6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9212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n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2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7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9212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c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7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7269"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i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7</a:t>
                      </a: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9866">
                <a:tc gridSpan="9">
                  <a:txBody>
                    <a:bodyPr/>
                    <a:lstStyle/>
                    <a:p>
                      <a:pPr algn="l" fontAlgn="b"/>
                      <a:r>
                        <a:rPr lang="en-CA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includes universal stress proteins, </a:t>
                      </a:r>
                      <a:r>
                        <a:rPr lang="en-CA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isin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resistance protein. </a:t>
                      </a:r>
                      <a:r>
                        <a:rPr lang="en-CA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s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.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ichiganesis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bsp.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pedonicus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; </a:t>
                      </a:r>
                      <a:r>
                        <a:rPr lang="en-CA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n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. m. 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bsp.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braskensis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; </a:t>
                      </a:r>
                      <a:r>
                        <a:rPr lang="en-CA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m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. m. 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bsp.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ichiganensis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;  </a:t>
                      </a:r>
                      <a:r>
                        <a:rPr lang="en-CA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mi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. m. 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bsp.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idiosus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; 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. m. 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bsp</a:t>
                      </a:r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. </a:t>
                      </a:r>
                      <a:r>
                        <a:rPr lang="en-CA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psici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.</a:t>
                      </a:r>
                      <a:b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</a:b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058" marR="8058" marT="805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 smtClean="0"/>
              <a:t>2</a:t>
            </a:r>
            <a:r>
              <a:rPr lang="en-US" dirty="0"/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2209127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3</TotalTime>
  <Words>113</Words>
  <Application>Microsoft Office PowerPoint</Application>
  <PresentationFormat>On-screen Show (4:3)</PresentationFormat>
  <Paragraphs>5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Tambong</dc:creator>
  <cp:lastModifiedBy>Tambong, James</cp:lastModifiedBy>
  <cp:revision>98</cp:revision>
  <cp:lastPrinted>2016-11-30T21:42:56Z</cp:lastPrinted>
  <dcterms:created xsi:type="dcterms:W3CDTF">2016-09-28T20:03:55Z</dcterms:created>
  <dcterms:modified xsi:type="dcterms:W3CDTF">2017-02-07T18:14:58Z</dcterms:modified>
</cp:coreProperties>
</file>